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284" y="-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2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组合 59"/>
          <p:cNvGrpSpPr/>
          <p:nvPr/>
        </p:nvGrpSpPr>
        <p:grpSpPr>
          <a:xfrm>
            <a:off x="1426447" y="471055"/>
            <a:ext cx="9832381" cy="5993526"/>
            <a:chOff x="1426447" y="471055"/>
            <a:chExt cx="9832381" cy="5993526"/>
          </a:xfrm>
        </p:grpSpPr>
        <p:grpSp>
          <p:nvGrpSpPr>
            <p:cNvPr id="57" name="组合 56"/>
            <p:cNvGrpSpPr/>
            <p:nvPr/>
          </p:nvGrpSpPr>
          <p:grpSpPr>
            <a:xfrm>
              <a:off x="1426447" y="753487"/>
              <a:ext cx="9832381" cy="3191164"/>
              <a:chOff x="1426447" y="753487"/>
              <a:chExt cx="9832381" cy="3191164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 rotWithShape="1">
              <a:blip r:embed="rId2"/>
              <a:srcRect b="44105"/>
              <a:stretch/>
            </p:blipFill>
            <p:spPr>
              <a:xfrm>
                <a:off x="1426447" y="753487"/>
                <a:ext cx="9832381" cy="3191164"/>
              </a:xfrm>
              <a:prstGeom prst="rect">
                <a:avLst/>
              </a:prstGeom>
            </p:spPr>
          </p:pic>
          <p:sp>
            <p:nvSpPr>
              <p:cNvPr id="9" name="矩形 8"/>
              <p:cNvSpPr/>
              <p:nvPr/>
            </p:nvSpPr>
            <p:spPr>
              <a:xfrm>
                <a:off x="1674912" y="969939"/>
                <a:ext cx="168828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ina mainland and H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2827470" y="1333019"/>
                <a:ext cx="53572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2872355" y="1897306"/>
                <a:ext cx="4908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2617478" y="2567696"/>
                <a:ext cx="74571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2151453" y="3084800"/>
                <a:ext cx="12117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utheast Asia 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2309700" y="3311019"/>
                <a:ext cx="105349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. of Kore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2707246" y="3507129"/>
                <a:ext cx="65594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xico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7683164" y="2658069"/>
                <a:ext cx="168828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ina mainland and H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7683163" y="905267"/>
                <a:ext cx="53572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7683163" y="1085935"/>
                <a:ext cx="4908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7683163" y="1246205"/>
                <a:ext cx="74571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7683163" y="1402468"/>
                <a:ext cx="12117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utheast Asia 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矩形 21"/>
              <p:cNvSpPr/>
              <p:nvPr/>
            </p:nvSpPr>
            <p:spPr>
              <a:xfrm>
                <a:off x="7683163" y="1592443"/>
                <a:ext cx="105349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. of Kore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矩形 22"/>
              <p:cNvSpPr/>
              <p:nvPr/>
            </p:nvSpPr>
            <p:spPr>
              <a:xfrm>
                <a:off x="7683163" y="1726974"/>
                <a:ext cx="65594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xico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矩形 23"/>
              <p:cNvSpPr/>
              <p:nvPr/>
            </p:nvSpPr>
            <p:spPr>
              <a:xfrm>
                <a:off x="3554622" y="1232953"/>
                <a:ext cx="2193229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→China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ainland and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K</a:t>
                </a:r>
              </a:p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51956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3554622" y="1815125"/>
                <a:ext cx="2148345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→China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ainland and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K</a:t>
                </a:r>
              </a:p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40788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3554622" y="2541915"/>
                <a:ext cx="2403222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→China mainland and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K</a:t>
                </a:r>
              </a:p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70254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8" name="组合 57"/>
            <p:cNvGrpSpPr/>
            <p:nvPr/>
          </p:nvGrpSpPr>
          <p:grpSpPr>
            <a:xfrm>
              <a:off x="1426448" y="3935413"/>
              <a:ext cx="7944999" cy="1921164"/>
              <a:chOff x="1426448" y="3935413"/>
              <a:chExt cx="7944999" cy="1921164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2"/>
              <a:srcRect t="55733" r="26110" b="10616"/>
              <a:stretch/>
            </p:blipFill>
            <p:spPr>
              <a:xfrm>
                <a:off x="1426448" y="3935413"/>
                <a:ext cx="7265212" cy="1921164"/>
              </a:xfrm>
              <a:prstGeom prst="rect">
                <a:avLst/>
              </a:prstGeom>
            </p:spPr>
          </p:pic>
          <p:sp>
            <p:nvSpPr>
              <p:cNvPr id="27" name="矩形 26"/>
              <p:cNvSpPr/>
              <p:nvPr/>
            </p:nvSpPr>
            <p:spPr>
              <a:xfrm>
                <a:off x="3500823" y="4296409"/>
                <a:ext cx="1716688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altLang="zh-C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→Southeast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sia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63415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1674703" y="4050728"/>
                <a:ext cx="168828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ina mainland and H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2827261" y="4334294"/>
                <a:ext cx="53572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2872146" y="4620279"/>
                <a:ext cx="4908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2617269" y="4945671"/>
                <a:ext cx="74571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/>
              <p:cNvSpPr/>
              <p:nvPr/>
            </p:nvSpPr>
            <p:spPr>
              <a:xfrm>
                <a:off x="2151244" y="5203477"/>
                <a:ext cx="12117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utheast Asia 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2309491" y="5366088"/>
                <a:ext cx="105349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. of Kore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2707037" y="5522443"/>
                <a:ext cx="65594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xico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矩形 34"/>
              <p:cNvSpPr/>
              <p:nvPr/>
            </p:nvSpPr>
            <p:spPr>
              <a:xfrm>
                <a:off x="3500823" y="4575595"/>
                <a:ext cx="1671804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altLang="zh-C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→Southeast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sia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2323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3500823" y="4887798"/>
                <a:ext cx="1926681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→Southeast Asia 5</a:t>
                </a:r>
                <a:endPara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1200"/>
                  </a:lnSpc>
                </a:pP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13794</a:t>
                </a:r>
                <a:endPara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7683164" y="5480411"/>
                <a:ext cx="168828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ina mainland and HK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7683163" y="3974096"/>
                <a:ext cx="53572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apan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/>
              <p:cNvSpPr/>
              <p:nvPr/>
            </p:nvSpPr>
            <p:spPr>
              <a:xfrm>
                <a:off x="7683163" y="4146813"/>
                <a:ext cx="4908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矩形 39"/>
              <p:cNvSpPr/>
              <p:nvPr/>
            </p:nvSpPr>
            <p:spPr>
              <a:xfrm>
                <a:off x="7683163" y="4309733"/>
                <a:ext cx="74571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urope 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矩形 40"/>
              <p:cNvSpPr/>
              <p:nvPr/>
            </p:nvSpPr>
            <p:spPr>
              <a:xfrm>
                <a:off x="7683163" y="4705085"/>
                <a:ext cx="12117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utheast Asia 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7683163" y="5122444"/>
                <a:ext cx="105349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. of Kore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7683163" y="5288779"/>
                <a:ext cx="65594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xico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文本框 1"/>
            <p:cNvSpPr txBox="1"/>
            <p:nvPr/>
          </p:nvSpPr>
          <p:spPr>
            <a:xfrm>
              <a:off x="1448040" y="471055"/>
              <a:ext cx="521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448040" y="3747110"/>
              <a:ext cx="521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>
              <a:off x="9499600" y="4628332"/>
              <a:ext cx="794714" cy="1597891"/>
              <a:chOff x="9499600" y="4628332"/>
              <a:chExt cx="794714" cy="1597891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2"/>
              <a:srcRect l="79345" t="61881" r="17320" b="10131"/>
              <a:stretch/>
            </p:blipFill>
            <p:spPr>
              <a:xfrm>
                <a:off x="9499600" y="4628332"/>
                <a:ext cx="327891" cy="1597891"/>
              </a:xfrm>
              <a:prstGeom prst="rect">
                <a:avLst/>
              </a:prstGeom>
            </p:spPr>
          </p:pic>
          <p:sp>
            <p:nvSpPr>
              <p:cNvPr id="46" name="矩形 45"/>
              <p:cNvSpPr/>
              <p:nvPr/>
            </p:nvSpPr>
            <p:spPr>
              <a:xfrm>
                <a:off x="9803474" y="4755648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9803474" y="4975705"/>
                <a:ext cx="335348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9803474" y="5177162"/>
                <a:ext cx="447558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C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9803474" y="5384608"/>
                <a:ext cx="423514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T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9803474" y="5585269"/>
                <a:ext cx="335348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P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/>
              <p:cNvSpPr/>
              <p:nvPr/>
            </p:nvSpPr>
            <p:spPr>
              <a:xfrm>
                <a:off x="9803474" y="5801376"/>
                <a:ext cx="490840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ther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/>
            <p:cNvGrpSpPr/>
            <p:nvPr/>
          </p:nvGrpSpPr>
          <p:grpSpPr>
            <a:xfrm>
              <a:off x="3755927" y="5943600"/>
              <a:ext cx="3855077" cy="520981"/>
              <a:chOff x="3755927" y="5943600"/>
              <a:chExt cx="3855077" cy="520981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 rotWithShape="1">
              <a:blip r:embed="rId2"/>
              <a:srcRect l="27665" t="90907" r="37100" b="3865"/>
              <a:stretch/>
            </p:blipFill>
            <p:spPr>
              <a:xfrm>
                <a:off x="4146550" y="5943600"/>
                <a:ext cx="3464454" cy="298450"/>
              </a:xfrm>
              <a:prstGeom prst="rect">
                <a:avLst/>
              </a:prstGeom>
            </p:spPr>
          </p:pic>
          <p:sp>
            <p:nvSpPr>
              <p:cNvPr id="52" name="矩形 51"/>
              <p:cNvSpPr/>
              <p:nvPr/>
            </p:nvSpPr>
            <p:spPr>
              <a:xfrm>
                <a:off x="3755927" y="6067425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ss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4660983" y="6218360"/>
                <a:ext cx="73609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0000 kg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5476122" y="6218360"/>
                <a:ext cx="73609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US" altLang="zh-CN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0000 kg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6184300" y="6218360"/>
                <a:ext cx="671979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zh-CN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000 kg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05168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20</Words>
  <Application>Microsoft Office PowerPoint</Application>
  <PresentationFormat>宽屏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谢Catherine</dc:creator>
  <cp:lastModifiedBy>谢 Catherine</cp:lastModifiedBy>
  <cp:revision>7</cp:revision>
  <dcterms:created xsi:type="dcterms:W3CDTF">2020-12-02T07:28:22Z</dcterms:created>
  <dcterms:modified xsi:type="dcterms:W3CDTF">2020-12-02T08:05:54Z</dcterms:modified>
</cp:coreProperties>
</file>